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sldIdLst>
    <p:sldId id="257" r:id="rId2"/>
  </p:sldIdLst>
  <p:sldSz cx="6300788" cy="37861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90" d="100"/>
          <a:sy n="190" d="100"/>
        </p:scale>
        <p:origin x="678" y="1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87599" y="619638"/>
            <a:ext cx="4725591" cy="1318154"/>
          </a:xfrm>
        </p:spPr>
        <p:txBody>
          <a:bodyPr anchor="b"/>
          <a:lstStyle>
            <a:lvl1pPr algn="ctr">
              <a:defRPr sz="310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87599" y="1988625"/>
            <a:ext cx="4725591" cy="914119"/>
          </a:xfrm>
        </p:spPr>
        <p:txBody>
          <a:bodyPr/>
          <a:lstStyle>
            <a:lvl1pPr marL="0" indent="0" algn="ctr">
              <a:buNone/>
              <a:defRPr sz="1240"/>
            </a:lvl1pPr>
            <a:lvl2pPr marL="236281" indent="0" algn="ctr">
              <a:buNone/>
              <a:defRPr sz="1034"/>
            </a:lvl2pPr>
            <a:lvl3pPr marL="472562" indent="0" algn="ctr">
              <a:buNone/>
              <a:defRPr sz="930"/>
            </a:lvl3pPr>
            <a:lvl4pPr marL="708843" indent="0" algn="ctr">
              <a:buNone/>
              <a:defRPr sz="827"/>
            </a:lvl4pPr>
            <a:lvl5pPr marL="945124" indent="0" algn="ctr">
              <a:buNone/>
              <a:defRPr sz="827"/>
            </a:lvl5pPr>
            <a:lvl6pPr marL="1181405" indent="0" algn="ctr">
              <a:buNone/>
              <a:defRPr sz="827"/>
            </a:lvl6pPr>
            <a:lvl7pPr marL="1417686" indent="0" algn="ctr">
              <a:buNone/>
              <a:defRPr sz="827"/>
            </a:lvl7pPr>
            <a:lvl8pPr marL="1653967" indent="0" algn="ctr">
              <a:buNone/>
              <a:defRPr sz="827"/>
            </a:lvl8pPr>
            <a:lvl9pPr marL="1890248" indent="0" algn="ctr">
              <a:buNone/>
              <a:defRPr sz="827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077420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79934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509002" y="201580"/>
            <a:ext cx="1358607" cy="3208619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33179" y="201580"/>
            <a:ext cx="3997062" cy="3208619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330508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814945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29897" y="943918"/>
            <a:ext cx="5434430" cy="1574949"/>
          </a:xfrm>
        </p:spPr>
        <p:txBody>
          <a:bodyPr anchor="b"/>
          <a:lstStyle>
            <a:lvl1pPr>
              <a:defRPr sz="3101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29897" y="2533767"/>
            <a:ext cx="5434430" cy="828228"/>
          </a:xfrm>
        </p:spPr>
        <p:txBody>
          <a:bodyPr/>
          <a:lstStyle>
            <a:lvl1pPr marL="0" indent="0">
              <a:buNone/>
              <a:defRPr sz="1240">
                <a:solidFill>
                  <a:schemeClr val="tx1">
                    <a:tint val="75000"/>
                  </a:schemeClr>
                </a:solidFill>
              </a:defRPr>
            </a:lvl1pPr>
            <a:lvl2pPr marL="236281" indent="0">
              <a:buNone/>
              <a:defRPr sz="1034">
                <a:solidFill>
                  <a:schemeClr val="tx1">
                    <a:tint val="75000"/>
                  </a:schemeClr>
                </a:solidFill>
              </a:defRPr>
            </a:lvl2pPr>
            <a:lvl3pPr marL="472562" indent="0">
              <a:buNone/>
              <a:defRPr sz="930">
                <a:solidFill>
                  <a:schemeClr val="tx1">
                    <a:tint val="75000"/>
                  </a:schemeClr>
                </a:solidFill>
              </a:defRPr>
            </a:lvl3pPr>
            <a:lvl4pPr marL="708843" indent="0">
              <a:buNone/>
              <a:defRPr sz="827">
                <a:solidFill>
                  <a:schemeClr val="tx1">
                    <a:tint val="75000"/>
                  </a:schemeClr>
                </a:solidFill>
              </a:defRPr>
            </a:lvl4pPr>
            <a:lvl5pPr marL="945124" indent="0">
              <a:buNone/>
              <a:defRPr sz="827">
                <a:solidFill>
                  <a:schemeClr val="tx1">
                    <a:tint val="75000"/>
                  </a:schemeClr>
                </a:solidFill>
              </a:defRPr>
            </a:lvl5pPr>
            <a:lvl6pPr marL="1181405" indent="0">
              <a:buNone/>
              <a:defRPr sz="827">
                <a:solidFill>
                  <a:schemeClr val="tx1">
                    <a:tint val="75000"/>
                  </a:schemeClr>
                </a:solidFill>
              </a:defRPr>
            </a:lvl6pPr>
            <a:lvl7pPr marL="1417686" indent="0">
              <a:buNone/>
              <a:defRPr sz="827">
                <a:solidFill>
                  <a:schemeClr val="tx1">
                    <a:tint val="75000"/>
                  </a:schemeClr>
                </a:solidFill>
              </a:defRPr>
            </a:lvl7pPr>
            <a:lvl8pPr marL="1653967" indent="0">
              <a:buNone/>
              <a:defRPr sz="827">
                <a:solidFill>
                  <a:schemeClr val="tx1">
                    <a:tint val="75000"/>
                  </a:schemeClr>
                </a:solidFill>
              </a:defRPr>
            </a:lvl8pPr>
            <a:lvl9pPr marL="1890248" indent="0">
              <a:buNone/>
              <a:defRPr sz="82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30866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33179" y="1007897"/>
            <a:ext cx="2677835" cy="240230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189774" y="1007897"/>
            <a:ext cx="2677835" cy="2402302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226036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000" y="201580"/>
            <a:ext cx="5434430" cy="731821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4000" y="928142"/>
            <a:ext cx="2665528" cy="454868"/>
          </a:xfrm>
        </p:spPr>
        <p:txBody>
          <a:bodyPr anchor="b"/>
          <a:lstStyle>
            <a:lvl1pPr marL="0" indent="0">
              <a:buNone/>
              <a:defRPr sz="1240" b="1"/>
            </a:lvl1pPr>
            <a:lvl2pPr marL="236281" indent="0">
              <a:buNone/>
              <a:defRPr sz="1034" b="1"/>
            </a:lvl2pPr>
            <a:lvl3pPr marL="472562" indent="0">
              <a:buNone/>
              <a:defRPr sz="930" b="1"/>
            </a:lvl3pPr>
            <a:lvl4pPr marL="708843" indent="0">
              <a:buNone/>
              <a:defRPr sz="827" b="1"/>
            </a:lvl4pPr>
            <a:lvl5pPr marL="945124" indent="0">
              <a:buNone/>
              <a:defRPr sz="827" b="1"/>
            </a:lvl5pPr>
            <a:lvl6pPr marL="1181405" indent="0">
              <a:buNone/>
              <a:defRPr sz="827" b="1"/>
            </a:lvl6pPr>
            <a:lvl7pPr marL="1417686" indent="0">
              <a:buNone/>
              <a:defRPr sz="827" b="1"/>
            </a:lvl7pPr>
            <a:lvl8pPr marL="1653967" indent="0">
              <a:buNone/>
              <a:defRPr sz="827" b="1"/>
            </a:lvl8pPr>
            <a:lvl9pPr marL="1890248" indent="0">
              <a:buNone/>
              <a:defRPr sz="827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34000" y="1383010"/>
            <a:ext cx="2665528" cy="2034200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189774" y="928142"/>
            <a:ext cx="2678656" cy="454868"/>
          </a:xfrm>
        </p:spPr>
        <p:txBody>
          <a:bodyPr anchor="b"/>
          <a:lstStyle>
            <a:lvl1pPr marL="0" indent="0">
              <a:buNone/>
              <a:defRPr sz="1240" b="1"/>
            </a:lvl1pPr>
            <a:lvl2pPr marL="236281" indent="0">
              <a:buNone/>
              <a:defRPr sz="1034" b="1"/>
            </a:lvl2pPr>
            <a:lvl3pPr marL="472562" indent="0">
              <a:buNone/>
              <a:defRPr sz="930" b="1"/>
            </a:lvl3pPr>
            <a:lvl4pPr marL="708843" indent="0">
              <a:buNone/>
              <a:defRPr sz="827" b="1"/>
            </a:lvl4pPr>
            <a:lvl5pPr marL="945124" indent="0">
              <a:buNone/>
              <a:defRPr sz="827" b="1"/>
            </a:lvl5pPr>
            <a:lvl6pPr marL="1181405" indent="0">
              <a:buNone/>
              <a:defRPr sz="827" b="1"/>
            </a:lvl6pPr>
            <a:lvl7pPr marL="1417686" indent="0">
              <a:buNone/>
              <a:defRPr sz="827" b="1"/>
            </a:lvl7pPr>
            <a:lvl8pPr marL="1653967" indent="0">
              <a:buNone/>
              <a:defRPr sz="827" b="1"/>
            </a:lvl8pPr>
            <a:lvl9pPr marL="1890248" indent="0">
              <a:buNone/>
              <a:defRPr sz="827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189774" y="1383010"/>
            <a:ext cx="2678656" cy="2034200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62990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561711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049642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000" y="252412"/>
            <a:ext cx="2032168" cy="883444"/>
          </a:xfrm>
        </p:spPr>
        <p:txBody>
          <a:bodyPr anchor="b"/>
          <a:lstStyle>
            <a:lvl1pPr>
              <a:defRPr sz="165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78656" y="545141"/>
            <a:ext cx="3189774" cy="2690647"/>
          </a:xfrm>
        </p:spPr>
        <p:txBody>
          <a:bodyPr/>
          <a:lstStyle>
            <a:lvl1pPr>
              <a:defRPr sz="1654"/>
            </a:lvl1pPr>
            <a:lvl2pPr>
              <a:defRPr sz="1447"/>
            </a:lvl2pPr>
            <a:lvl3pPr>
              <a:defRPr sz="1240"/>
            </a:lvl3pPr>
            <a:lvl4pPr>
              <a:defRPr sz="1034"/>
            </a:lvl4pPr>
            <a:lvl5pPr>
              <a:defRPr sz="1034"/>
            </a:lvl5pPr>
            <a:lvl6pPr>
              <a:defRPr sz="1034"/>
            </a:lvl6pPr>
            <a:lvl7pPr>
              <a:defRPr sz="1034"/>
            </a:lvl7pPr>
            <a:lvl8pPr>
              <a:defRPr sz="1034"/>
            </a:lvl8pPr>
            <a:lvl9pPr>
              <a:defRPr sz="1034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4000" y="1135857"/>
            <a:ext cx="2032168" cy="2104314"/>
          </a:xfrm>
        </p:spPr>
        <p:txBody>
          <a:bodyPr/>
          <a:lstStyle>
            <a:lvl1pPr marL="0" indent="0">
              <a:buNone/>
              <a:defRPr sz="827"/>
            </a:lvl1pPr>
            <a:lvl2pPr marL="236281" indent="0">
              <a:buNone/>
              <a:defRPr sz="724"/>
            </a:lvl2pPr>
            <a:lvl3pPr marL="472562" indent="0">
              <a:buNone/>
              <a:defRPr sz="620"/>
            </a:lvl3pPr>
            <a:lvl4pPr marL="708843" indent="0">
              <a:buNone/>
              <a:defRPr sz="517"/>
            </a:lvl4pPr>
            <a:lvl5pPr marL="945124" indent="0">
              <a:buNone/>
              <a:defRPr sz="517"/>
            </a:lvl5pPr>
            <a:lvl6pPr marL="1181405" indent="0">
              <a:buNone/>
              <a:defRPr sz="517"/>
            </a:lvl6pPr>
            <a:lvl7pPr marL="1417686" indent="0">
              <a:buNone/>
              <a:defRPr sz="517"/>
            </a:lvl7pPr>
            <a:lvl8pPr marL="1653967" indent="0">
              <a:buNone/>
              <a:defRPr sz="517"/>
            </a:lvl8pPr>
            <a:lvl9pPr marL="1890248" indent="0">
              <a:buNone/>
              <a:defRPr sz="517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424896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34000" y="252412"/>
            <a:ext cx="2032168" cy="883444"/>
          </a:xfrm>
        </p:spPr>
        <p:txBody>
          <a:bodyPr anchor="b"/>
          <a:lstStyle>
            <a:lvl1pPr>
              <a:defRPr sz="1654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678656" y="545141"/>
            <a:ext cx="3189774" cy="2690647"/>
          </a:xfrm>
        </p:spPr>
        <p:txBody>
          <a:bodyPr anchor="t"/>
          <a:lstStyle>
            <a:lvl1pPr marL="0" indent="0">
              <a:buNone/>
              <a:defRPr sz="1654"/>
            </a:lvl1pPr>
            <a:lvl2pPr marL="236281" indent="0">
              <a:buNone/>
              <a:defRPr sz="1447"/>
            </a:lvl2pPr>
            <a:lvl3pPr marL="472562" indent="0">
              <a:buNone/>
              <a:defRPr sz="1240"/>
            </a:lvl3pPr>
            <a:lvl4pPr marL="708843" indent="0">
              <a:buNone/>
              <a:defRPr sz="1034"/>
            </a:lvl4pPr>
            <a:lvl5pPr marL="945124" indent="0">
              <a:buNone/>
              <a:defRPr sz="1034"/>
            </a:lvl5pPr>
            <a:lvl6pPr marL="1181405" indent="0">
              <a:buNone/>
              <a:defRPr sz="1034"/>
            </a:lvl6pPr>
            <a:lvl7pPr marL="1417686" indent="0">
              <a:buNone/>
              <a:defRPr sz="1034"/>
            </a:lvl7pPr>
            <a:lvl8pPr marL="1653967" indent="0">
              <a:buNone/>
              <a:defRPr sz="1034"/>
            </a:lvl8pPr>
            <a:lvl9pPr marL="1890248" indent="0">
              <a:buNone/>
              <a:defRPr sz="1034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34000" y="1135857"/>
            <a:ext cx="2032168" cy="2104314"/>
          </a:xfrm>
        </p:spPr>
        <p:txBody>
          <a:bodyPr/>
          <a:lstStyle>
            <a:lvl1pPr marL="0" indent="0">
              <a:buNone/>
              <a:defRPr sz="827"/>
            </a:lvl1pPr>
            <a:lvl2pPr marL="236281" indent="0">
              <a:buNone/>
              <a:defRPr sz="724"/>
            </a:lvl2pPr>
            <a:lvl3pPr marL="472562" indent="0">
              <a:buNone/>
              <a:defRPr sz="620"/>
            </a:lvl3pPr>
            <a:lvl4pPr marL="708843" indent="0">
              <a:buNone/>
              <a:defRPr sz="517"/>
            </a:lvl4pPr>
            <a:lvl5pPr marL="945124" indent="0">
              <a:buNone/>
              <a:defRPr sz="517"/>
            </a:lvl5pPr>
            <a:lvl6pPr marL="1181405" indent="0">
              <a:buNone/>
              <a:defRPr sz="517"/>
            </a:lvl6pPr>
            <a:lvl7pPr marL="1417686" indent="0">
              <a:buNone/>
              <a:defRPr sz="517"/>
            </a:lvl7pPr>
            <a:lvl8pPr marL="1653967" indent="0">
              <a:buNone/>
              <a:defRPr sz="517"/>
            </a:lvl8pPr>
            <a:lvl9pPr marL="1890248" indent="0">
              <a:buNone/>
              <a:defRPr sz="517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335B7E0-F01F-43CB-8AEC-55FB7F2B3873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30653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33179" y="201580"/>
            <a:ext cx="5434430" cy="73182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33179" y="1007897"/>
            <a:ext cx="5434430" cy="24023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33179" y="3509236"/>
            <a:ext cx="1417677" cy="20157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335B7E0-F01F-43CB-8AEC-55FB7F2B3873}" type="datetimeFigureOut">
              <a:rPr lang="zh-CN" altLang="en-US" smtClean="0"/>
              <a:t>2023/10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087136" y="3509236"/>
            <a:ext cx="2126516" cy="20157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449932" y="3509236"/>
            <a:ext cx="1417677" cy="20157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A7B351-87BF-4BC9-8E74-E4EEEFDEE970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65985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472562" rtl="0" eaLnBrk="1" latinLnBrk="0" hangingPunct="1">
        <a:lnSpc>
          <a:spcPct val="90000"/>
        </a:lnSpc>
        <a:spcBef>
          <a:spcPct val="0"/>
        </a:spcBef>
        <a:buNone/>
        <a:defRPr sz="227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18140" indent="-118140" algn="l" defTabSz="472562" rtl="0" eaLnBrk="1" latinLnBrk="0" hangingPunct="1">
        <a:lnSpc>
          <a:spcPct val="90000"/>
        </a:lnSpc>
        <a:spcBef>
          <a:spcPts val="517"/>
        </a:spcBef>
        <a:buFont typeface="Arial" panose="020B0604020202020204" pitchFamily="34" charset="0"/>
        <a:buChar char="•"/>
        <a:defRPr sz="1447" kern="1200">
          <a:solidFill>
            <a:schemeClr val="tx1"/>
          </a:solidFill>
          <a:latin typeface="+mn-lt"/>
          <a:ea typeface="+mn-ea"/>
          <a:cs typeface="+mn-cs"/>
        </a:defRPr>
      </a:lvl1pPr>
      <a:lvl2pPr marL="354421" indent="-118140" algn="l" defTabSz="472562" rtl="0" eaLnBrk="1" latinLnBrk="0" hangingPunct="1">
        <a:lnSpc>
          <a:spcPct val="90000"/>
        </a:lnSpc>
        <a:spcBef>
          <a:spcPts val="258"/>
        </a:spcBef>
        <a:buFont typeface="Arial" panose="020B0604020202020204" pitchFamily="34" charset="0"/>
        <a:buChar char="•"/>
        <a:defRPr sz="1240" kern="1200">
          <a:solidFill>
            <a:schemeClr val="tx1"/>
          </a:solidFill>
          <a:latin typeface="+mn-lt"/>
          <a:ea typeface="+mn-ea"/>
          <a:cs typeface="+mn-cs"/>
        </a:defRPr>
      </a:lvl2pPr>
      <a:lvl3pPr marL="590702" indent="-118140" algn="l" defTabSz="472562" rtl="0" eaLnBrk="1" latinLnBrk="0" hangingPunct="1">
        <a:lnSpc>
          <a:spcPct val="90000"/>
        </a:lnSpc>
        <a:spcBef>
          <a:spcPts val="258"/>
        </a:spcBef>
        <a:buFont typeface="Arial" panose="020B0604020202020204" pitchFamily="34" charset="0"/>
        <a:buChar char="•"/>
        <a:defRPr sz="1034" kern="1200">
          <a:solidFill>
            <a:schemeClr val="tx1"/>
          </a:solidFill>
          <a:latin typeface="+mn-lt"/>
          <a:ea typeface="+mn-ea"/>
          <a:cs typeface="+mn-cs"/>
        </a:defRPr>
      </a:lvl3pPr>
      <a:lvl4pPr marL="826983" indent="-118140" algn="l" defTabSz="472562" rtl="0" eaLnBrk="1" latinLnBrk="0" hangingPunct="1">
        <a:lnSpc>
          <a:spcPct val="90000"/>
        </a:lnSpc>
        <a:spcBef>
          <a:spcPts val="258"/>
        </a:spcBef>
        <a:buFont typeface="Arial" panose="020B0604020202020204" pitchFamily="34" charset="0"/>
        <a:buChar char="•"/>
        <a:defRPr sz="930" kern="1200">
          <a:solidFill>
            <a:schemeClr val="tx1"/>
          </a:solidFill>
          <a:latin typeface="+mn-lt"/>
          <a:ea typeface="+mn-ea"/>
          <a:cs typeface="+mn-cs"/>
        </a:defRPr>
      </a:lvl4pPr>
      <a:lvl5pPr marL="1063264" indent="-118140" algn="l" defTabSz="472562" rtl="0" eaLnBrk="1" latinLnBrk="0" hangingPunct="1">
        <a:lnSpc>
          <a:spcPct val="90000"/>
        </a:lnSpc>
        <a:spcBef>
          <a:spcPts val="258"/>
        </a:spcBef>
        <a:buFont typeface="Arial" panose="020B0604020202020204" pitchFamily="34" charset="0"/>
        <a:buChar char="•"/>
        <a:defRPr sz="930" kern="1200">
          <a:solidFill>
            <a:schemeClr val="tx1"/>
          </a:solidFill>
          <a:latin typeface="+mn-lt"/>
          <a:ea typeface="+mn-ea"/>
          <a:cs typeface="+mn-cs"/>
        </a:defRPr>
      </a:lvl5pPr>
      <a:lvl6pPr marL="1299545" indent="-118140" algn="l" defTabSz="472562" rtl="0" eaLnBrk="1" latinLnBrk="0" hangingPunct="1">
        <a:lnSpc>
          <a:spcPct val="90000"/>
        </a:lnSpc>
        <a:spcBef>
          <a:spcPts val="258"/>
        </a:spcBef>
        <a:buFont typeface="Arial" panose="020B0604020202020204" pitchFamily="34" charset="0"/>
        <a:buChar char="•"/>
        <a:defRPr sz="930" kern="1200">
          <a:solidFill>
            <a:schemeClr val="tx1"/>
          </a:solidFill>
          <a:latin typeface="+mn-lt"/>
          <a:ea typeface="+mn-ea"/>
          <a:cs typeface="+mn-cs"/>
        </a:defRPr>
      </a:lvl6pPr>
      <a:lvl7pPr marL="1535826" indent="-118140" algn="l" defTabSz="472562" rtl="0" eaLnBrk="1" latinLnBrk="0" hangingPunct="1">
        <a:lnSpc>
          <a:spcPct val="90000"/>
        </a:lnSpc>
        <a:spcBef>
          <a:spcPts val="258"/>
        </a:spcBef>
        <a:buFont typeface="Arial" panose="020B0604020202020204" pitchFamily="34" charset="0"/>
        <a:buChar char="•"/>
        <a:defRPr sz="930" kern="1200">
          <a:solidFill>
            <a:schemeClr val="tx1"/>
          </a:solidFill>
          <a:latin typeface="+mn-lt"/>
          <a:ea typeface="+mn-ea"/>
          <a:cs typeface="+mn-cs"/>
        </a:defRPr>
      </a:lvl7pPr>
      <a:lvl8pPr marL="1772107" indent="-118140" algn="l" defTabSz="472562" rtl="0" eaLnBrk="1" latinLnBrk="0" hangingPunct="1">
        <a:lnSpc>
          <a:spcPct val="90000"/>
        </a:lnSpc>
        <a:spcBef>
          <a:spcPts val="258"/>
        </a:spcBef>
        <a:buFont typeface="Arial" panose="020B0604020202020204" pitchFamily="34" charset="0"/>
        <a:buChar char="•"/>
        <a:defRPr sz="930" kern="1200">
          <a:solidFill>
            <a:schemeClr val="tx1"/>
          </a:solidFill>
          <a:latin typeface="+mn-lt"/>
          <a:ea typeface="+mn-ea"/>
          <a:cs typeface="+mn-cs"/>
        </a:defRPr>
      </a:lvl8pPr>
      <a:lvl9pPr marL="2008388" indent="-118140" algn="l" defTabSz="472562" rtl="0" eaLnBrk="1" latinLnBrk="0" hangingPunct="1">
        <a:lnSpc>
          <a:spcPct val="90000"/>
        </a:lnSpc>
        <a:spcBef>
          <a:spcPts val="258"/>
        </a:spcBef>
        <a:buFont typeface="Arial" panose="020B0604020202020204" pitchFamily="34" charset="0"/>
        <a:buChar char="•"/>
        <a:defRPr sz="9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72562" rtl="0" eaLnBrk="1" latinLnBrk="0" hangingPunct="1">
        <a:defRPr sz="930" kern="1200">
          <a:solidFill>
            <a:schemeClr val="tx1"/>
          </a:solidFill>
          <a:latin typeface="+mn-lt"/>
          <a:ea typeface="+mn-ea"/>
          <a:cs typeface="+mn-cs"/>
        </a:defRPr>
      </a:lvl1pPr>
      <a:lvl2pPr marL="236281" algn="l" defTabSz="472562" rtl="0" eaLnBrk="1" latinLnBrk="0" hangingPunct="1">
        <a:defRPr sz="930" kern="1200">
          <a:solidFill>
            <a:schemeClr val="tx1"/>
          </a:solidFill>
          <a:latin typeface="+mn-lt"/>
          <a:ea typeface="+mn-ea"/>
          <a:cs typeface="+mn-cs"/>
        </a:defRPr>
      </a:lvl2pPr>
      <a:lvl3pPr marL="472562" algn="l" defTabSz="472562" rtl="0" eaLnBrk="1" latinLnBrk="0" hangingPunct="1">
        <a:defRPr sz="930" kern="1200">
          <a:solidFill>
            <a:schemeClr val="tx1"/>
          </a:solidFill>
          <a:latin typeface="+mn-lt"/>
          <a:ea typeface="+mn-ea"/>
          <a:cs typeface="+mn-cs"/>
        </a:defRPr>
      </a:lvl3pPr>
      <a:lvl4pPr marL="708843" algn="l" defTabSz="472562" rtl="0" eaLnBrk="1" latinLnBrk="0" hangingPunct="1">
        <a:defRPr sz="930" kern="1200">
          <a:solidFill>
            <a:schemeClr val="tx1"/>
          </a:solidFill>
          <a:latin typeface="+mn-lt"/>
          <a:ea typeface="+mn-ea"/>
          <a:cs typeface="+mn-cs"/>
        </a:defRPr>
      </a:lvl4pPr>
      <a:lvl5pPr marL="945124" algn="l" defTabSz="472562" rtl="0" eaLnBrk="1" latinLnBrk="0" hangingPunct="1">
        <a:defRPr sz="930" kern="1200">
          <a:solidFill>
            <a:schemeClr val="tx1"/>
          </a:solidFill>
          <a:latin typeface="+mn-lt"/>
          <a:ea typeface="+mn-ea"/>
          <a:cs typeface="+mn-cs"/>
        </a:defRPr>
      </a:lvl5pPr>
      <a:lvl6pPr marL="1181405" algn="l" defTabSz="472562" rtl="0" eaLnBrk="1" latinLnBrk="0" hangingPunct="1">
        <a:defRPr sz="930" kern="1200">
          <a:solidFill>
            <a:schemeClr val="tx1"/>
          </a:solidFill>
          <a:latin typeface="+mn-lt"/>
          <a:ea typeface="+mn-ea"/>
          <a:cs typeface="+mn-cs"/>
        </a:defRPr>
      </a:lvl6pPr>
      <a:lvl7pPr marL="1417686" algn="l" defTabSz="472562" rtl="0" eaLnBrk="1" latinLnBrk="0" hangingPunct="1">
        <a:defRPr sz="930" kern="1200">
          <a:solidFill>
            <a:schemeClr val="tx1"/>
          </a:solidFill>
          <a:latin typeface="+mn-lt"/>
          <a:ea typeface="+mn-ea"/>
          <a:cs typeface="+mn-cs"/>
        </a:defRPr>
      </a:lvl7pPr>
      <a:lvl8pPr marL="1653967" algn="l" defTabSz="472562" rtl="0" eaLnBrk="1" latinLnBrk="0" hangingPunct="1">
        <a:defRPr sz="930" kern="1200">
          <a:solidFill>
            <a:schemeClr val="tx1"/>
          </a:solidFill>
          <a:latin typeface="+mn-lt"/>
          <a:ea typeface="+mn-ea"/>
          <a:cs typeface="+mn-cs"/>
        </a:defRPr>
      </a:lvl8pPr>
      <a:lvl9pPr marL="1890248" algn="l" defTabSz="472562" rtl="0" eaLnBrk="1" latinLnBrk="0" hangingPunct="1">
        <a:defRPr sz="9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B2D43D90-963C-4C11-84B1-D67AF1E8DB40}"/>
              </a:ext>
            </a:extLst>
          </p:cNvPr>
          <p:cNvGrpSpPr/>
          <p:nvPr/>
        </p:nvGrpSpPr>
        <p:grpSpPr>
          <a:xfrm>
            <a:off x="192525" y="515774"/>
            <a:ext cx="5874612" cy="2905364"/>
            <a:chOff x="192525" y="440412"/>
            <a:chExt cx="5874612" cy="2905364"/>
          </a:xfrm>
        </p:grpSpPr>
        <p:sp>
          <p:nvSpPr>
            <p:cNvPr id="79" name="矩形: 圆角 78">
              <a:extLst>
                <a:ext uri="{FF2B5EF4-FFF2-40B4-BE49-F238E27FC236}">
                  <a16:creationId xmlns:a16="http://schemas.microsoft.com/office/drawing/2014/main" id="{A3A49375-B317-4613-8A1E-4E0A00E0E34C}"/>
                </a:ext>
              </a:extLst>
            </p:cNvPr>
            <p:cNvSpPr/>
            <p:nvPr/>
          </p:nvSpPr>
          <p:spPr>
            <a:xfrm>
              <a:off x="3259380" y="440412"/>
              <a:ext cx="2807757" cy="2905364"/>
            </a:xfrm>
            <a:prstGeom prst="roundRect">
              <a:avLst>
                <a:gd name="adj" fmla="val 2851"/>
              </a:avLst>
            </a:prstGeom>
            <a:solidFill>
              <a:schemeClr val="bg1"/>
            </a:solidFill>
            <a:ln w="15875"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84010" tIns="42006" rIns="84010" bIns="42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 sz="1654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8" name="矩形: 圆角 77">
              <a:extLst>
                <a:ext uri="{FF2B5EF4-FFF2-40B4-BE49-F238E27FC236}">
                  <a16:creationId xmlns:a16="http://schemas.microsoft.com/office/drawing/2014/main" id="{F1F0CC2E-FD8D-4F3A-B345-4D37A1F94A29}"/>
                </a:ext>
              </a:extLst>
            </p:cNvPr>
            <p:cNvSpPr/>
            <p:nvPr/>
          </p:nvSpPr>
          <p:spPr>
            <a:xfrm>
              <a:off x="192525" y="440412"/>
              <a:ext cx="2807757" cy="2905364"/>
            </a:xfrm>
            <a:prstGeom prst="roundRect">
              <a:avLst>
                <a:gd name="adj" fmla="val 3059"/>
              </a:avLst>
            </a:prstGeom>
            <a:solidFill>
              <a:schemeClr val="bg1"/>
            </a:solidFill>
            <a:ln w="15875">
              <a:solidFill>
                <a:schemeClr val="tx1"/>
              </a:solidFill>
              <a:prstDash val="sysDot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84010" tIns="42006" rIns="84010" bIns="42006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endParaRPr lang="zh-CN" altLang="en-US" sz="1654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" name="矩形 4">
              <a:extLst>
                <a:ext uri="{FF2B5EF4-FFF2-40B4-BE49-F238E27FC236}">
                  <a16:creationId xmlns:a16="http://schemas.microsoft.com/office/drawing/2014/main" id="{693E3116-F4C5-473D-8ACC-E54D70567D1B}"/>
                </a:ext>
              </a:extLst>
            </p:cNvPr>
            <p:cNvSpPr/>
            <p:nvPr/>
          </p:nvSpPr>
          <p:spPr>
            <a:xfrm>
              <a:off x="330023" y="805768"/>
              <a:ext cx="970733" cy="296220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8596" tIns="49299" rIns="98596" bIns="49299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zh-CN" sz="964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WES data</a:t>
              </a:r>
              <a:endParaRPr lang="zh-CN" altLang="en-US" sz="964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" name="矩形 5">
              <a:extLst>
                <a:ext uri="{FF2B5EF4-FFF2-40B4-BE49-F238E27FC236}">
                  <a16:creationId xmlns:a16="http://schemas.microsoft.com/office/drawing/2014/main" id="{EDA480BB-46AF-40BB-BAFE-648797146A35}"/>
                </a:ext>
              </a:extLst>
            </p:cNvPr>
            <p:cNvSpPr/>
            <p:nvPr/>
          </p:nvSpPr>
          <p:spPr>
            <a:xfrm>
              <a:off x="1546454" y="805768"/>
              <a:ext cx="1342930" cy="296220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8596" tIns="49299" rIns="98596" bIns="49299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zh-CN" sz="964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NA-seq data</a:t>
              </a:r>
              <a:endParaRPr lang="zh-CN" altLang="en-US" sz="964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矩形 11">
              <a:extLst>
                <a:ext uri="{FF2B5EF4-FFF2-40B4-BE49-F238E27FC236}">
                  <a16:creationId xmlns:a16="http://schemas.microsoft.com/office/drawing/2014/main" id="{8976C69E-74AA-4150-B99C-EC76C4CB5D2B}"/>
                </a:ext>
              </a:extLst>
            </p:cNvPr>
            <p:cNvSpPr/>
            <p:nvPr/>
          </p:nvSpPr>
          <p:spPr>
            <a:xfrm>
              <a:off x="3382817" y="805768"/>
              <a:ext cx="822324" cy="296220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8596" tIns="49299" rIns="98596" bIns="49299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zh-CN" sz="964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NA-seq</a:t>
              </a:r>
              <a:endParaRPr lang="zh-CN" altLang="en-US" sz="964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" name="矩形 12">
              <a:extLst>
                <a:ext uri="{FF2B5EF4-FFF2-40B4-BE49-F238E27FC236}">
                  <a16:creationId xmlns:a16="http://schemas.microsoft.com/office/drawing/2014/main" id="{AADFB018-1AC7-41D2-A47A-2961F53D1C63}"/>
                </a:ext>
              </a:extLst>
            </p:cNvPr>
            <p:cNvSpPr/>
            <p:nvPr/>
          </p:nvSpPr>
          <p:spPr>
            <a:xfrm>
              <a:off x="4262271" y="805768"/>
              <a:ext cx="787585" cy="296220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8596" tIns="49299" rIns="98596" bIns="49299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zh-CN" sz="964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icroarray</a:t>
              </a:r>
              <a:endParaRPr lang="zh-CN" altLang="en-US" sz="964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" name="矩形 13">
              <a:extLst>
                <a:ext uri="{FF2B5EF4-FFF2-40B4-BE49-F238E27FC236}">
                  <a16:creationId xmlns:a16="http://schemas.microsoft.com/office/drawing/2014/main" id="{6AC4703A-0FDD-42EC-9E3D-91C9132707CB}"/>
                </a:ext>
              </a:extLst>
            </p:cNvPr>
            <p:cNvSpPr/>
            <p:nvPr/>
          </p:nvSpPr>
          <p:spPr>
            <a:xfrm>
              <a:off x="5100639" y="805768"/>
              <a:ext cx="843067" cy="296220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8596" tIns="49299" rIns="98596" bIns="49299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zh-CN" sz="964" dirty="0" err="1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RNA</a:t>
              </a:r>
              <a:r>
                <a:rPr lang="en-US" altLang="zh-CN" sz="964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seq</a:t>
              </a:r>
              <a:endParaRPr lang="zh-CN" altLang="en-US" sz="964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矩形 6">
              <a:extLst>
                <a:ext uri="{FF2B5EF4-FFF2-40B4-BE49-F238E27FC236}">
                  <a16:creationId xmlns:a16="http://schemas.microsoft.com/office/drawing/2014/main" id="{86CC5CEC-FB03-401C-BEFB-D2B95C637C5B}"/>
                </a:ext>
              </a:extLst>
            </p:cNvPr>
            <p:cNvSpPr/>
            <p:nvPr/>
          </p:nvSpPr>
          <p:spPr>
            <a:xfrm>
              <a:off x="330023" y="1331774"/>
              <a:ext cx="970733" cy="296220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8596" tIns="49299" rIns="98596" bIns="49299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zh-CN" sz="964" dirty="0" err="1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SIsensor</a:t>
              </a:r>
              <a:r>
                <a:rPr lang="en-US" altLang="zh-CN" sz="964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 score</a:t>
              </a:r>
              <a:endParaRPr lang="zh-CN" altLang="en-US" sz="964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矩形 7">
              <a:extLst>
                <a:ext uri="{FF2B5EF4-FFF2-40B4-BE49-F238E27FC236}">
                  <a16:creationId xmlns:a16="http://schemas.microsoft.com/office/drawing/2014/main" id="{A06C3599-3D49-4057-9F8D-B7CC6D7DBF3A}"/>
                </a:ext>
              </a:extLst>
            </p:cNvPr>
            <p:cNvSpPr/>
            <p:nvPr/>
          </p:nvSpPr>
          <p:spPr>
            <a:xfrm>
              <a:off x="1546454" y="1331774"/>
              <a:ext cx="1342930" cy="296220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8596" tIns="49299" rIns="98596" bIns="49299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zh-CN" sz="964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-score standardization</a:t>
              </a:r>
              <a:endParaRPr lang="zh-CN" altLang="en-US" sz="964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矩形 15">
              <a:extLst>
                <a:ext uri="{FF2B5EF4-FFF2-40B4-BE49-F238E27FC236}">
                  <a16:creationId xmlns:a16="http://schemas.microsoft.com/office/drawing/2014/main" id="{54866246-40A5-499A-8624-25FF0444721C}"/>
                </a:ext>
              </a:extLst>
            </p:cNvPr>
            <p:cNvSpPr/>
            <p:nvPr/>
          </p:nvSpPr>
          <p:spPr>
            <a:xfrm>
              <a:off x="3382819" y="1331774"/>
              <a:ext cx="2560884" cy="296220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8596" tIns="49299" rIns="98596" bIns="49299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zh-CN" sz="964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Z-score standardization</a:t>
              </a:r>
              <a:endParaRPr lang="zh-CN" altLang="en-US" sz="964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矩形 8">
              <a:extLst>
                <a:ext uri="{FF2B5EF4-FFF2-40B4-BE49-F238E27FC236}">
                  <a16:creationId xmlns:a16="http://schemas.microsoft.com/office/drawing/2014/main" id="{7A0C7598-7431-4F41-AF18-31BB1D473FF6}"/>
                </a:ext>
              </a:extLst>
            </p:cNvPr>
            <p:cNvSpPr/>
            <p:nvPr/>
          </p:nvSpPr>
          <p:spPr>
            <a:xfrm>
              <a:off x="330024" y="1857782"/>
              <a:ext cx="2560884" cy="296220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8596" tIns="49299" rIns="98596" bIns="49299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zh-CN" sz="964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Random forest regressor</a:t>
              </a:r>
              <a:endParaRPr lang="zh-CN" altLang="en-US" sz="964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" name="矩形 16">
              <a:extLst>
                <a:ext uri="{FF2B5EF4-FFF2-40B4-BE49-F238E27FC236}">
                  <a16:creationId xmlns:a16="http://schemas.microsoft.com/office/drawing/2014/main" id="{F2C935E5-5A86-47B5-A8AC-30B4FDA747B1}"/>
                </a:ext>
              </a:extLst>
            </p:cNvPr>
            <p:cNvSpPr/>
            <p:nvPr/>
          </p:nvSpPr>
          <p:spPr>
            <a:xfrm>
              <a:off x="3382819" y="1857782"/>
              <a:ext cx="2560884" cy="296220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8596" tIns="49299" rIns="98596" bIns="49299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zh-CN" sz="964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SI score evaluation</a:t>
              </a:r>
              <a:endParaRPr lang="zh-CN" altLang="en-US" sz="964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矩形 9">
              <a:extLst>
                <a:ext uri="{FF2B5EF4-FFF2-40B4-BE49-F238E27FC236}">
                  <a16:creationId xmlns:a16="http://schemas.microsoft.com/office/drawing/2014/main" id="{FE386DB4-1D78-4EE6-943E-B91D4F362698}"/>
                </a:ext>
              </a:extLst>
            </p:cNvPr>
            <p:cNvSpPr/>
            <p:nvPr/>
          </p:nvSpPr>
          <p:spPr>
            <a:xfrm>
              <a:off x="330024" y="2383790"/>
              <a:ext cx="2560884" cy="296220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8596" tIns="49299" rIns="98596" bIns="49299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zh-CN" sz="964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nformative gene set</a:t>
              </a:r>
              <a:endParaRPr lang="zh-CN" altLang="en-US" sz="964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矩形 17">
              <a:extLst>
                <a:ext uri="{FF2B5EF4-FFF2-40B4-BE49-F238E27FC236}">
                  <a16:creationId xmlns:a16="http://schemas.microsoft.com/office/drawing/2014/main" id="{9254ABAD-32DB-4281-959D-7CCA0BEB8129}"/>
                </a:ext>
              </a:extLst>
            </p:cNvPr>
            <p:cNvSpPr/>
            <p:nvPr/>
          </p:nvSpPr>
          <p:spPr>
            <a:xfrm>
              <a:off x="3382819" y="2383790"/>
              <a:ext cx="2560884" cy="296220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8596" tIns="49299" rIns="98596" bIns="49299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zh-CN" sz="964" dirty="0" err="1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SIsensor</a:t>
              </a:r>
              <a:r>
                <a:rPr lang="en-US" altLang="zh-CN" sz="964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-RNA score</a:t>
              </a:r>
              <a:endParaRPr lang="zh-CN" altLang="en-US" sz="964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矩形 10">
              <a:extLst>
                <a:ext uri="{FF2B5EF4-FFF2-40B4-BE49-F238E27FC236}">
                  <a16:creationId xmlns:a16="http://schemas.microsoft.com/office/drawing/2014/main" id="{DAE117F8-15DD-4D2D-8C22-94100E74C333}"/>
                </a:ext>
              </a:extLst>
            </p:cNvPr>
            <p:cNvSpPr/>
            <p:nvPr/>
          </p:nvSpPr>
          <p:spPr>
            <a:xfrm>
              <a:off x="330024" y="2909798"/>
              <a:ext cx="2560884" cy="296220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8596" tIns="49299" rIns="98596" bIns="49299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zh-CN" sz="964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VM regression model</a:t>
              </a:r>
              <a:endParaRPr lang="zh-CN" altLang="en-US" sz="964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9" name="矩形 18">
              <a:extLst>
                <a:ext uri="{FF2B5EF4-FFF2-40B4-BE49-F238E27FC236}">
                  <a16:creationId xmlns:a16="http://schemas.microsoft.com/office/drawing/2014/main" id="{3F0F13A7-0EA4-4FB4-AE8D-5C1BD01A71E7}"/>
                </a:ext>
              </a:extLst>
            </p:cNvPr>
            <p:cNvSpPr/>
            <p:nvPr/>
          </p:nvSpPr>
          <p:spPr>
            <a:xfrm>
              <a:off x="3382819" y="2909798"/>
              <a:ext cx="2560884" cy="296220"/>
            </a:xfrm>
            <a:prstGeom prst="rect">
              <a:avLst/>
            </a:prstGeom>
            <a:noFill/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98596" tIns="49299" rIns="98596" bIns="49299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algn="ctr"/>
              <a:r>
                <a:rPr lang="en-US" altLang="zh-CN" sz="964" dirty="0">
                  <a:solidFill>
                    <a:schemeClr val="tx1">
                      <a:lumMod val="95000"/>
                      <a:lumOff val="5000"/>
                    </a:schemeClr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SI status prediction</a:t>
              </a:r>
              <a:endParaRPr lang="zh-CN" altLang="en-US" sz="964" dirty="0">
                <a:solidFill>
                  <a:schemeClr val="tx1">
                    <a:lumMod val="95000"/>
                    <a:lumOff val="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21" name="直接箭头连接符 20">
              <a:extLst>
                <a:ext uri="{FF2B5EF4-FFF2-40B4-BE49-F238E27FC236}">
                  <a16:creationId xmlns:a16="http://schemas.microsoft.com/office/drawing/2014/main" id="{6FFD21D3-1A0C-4893-A7C8-45F39EB9C2F2}"/>
                </a:ext>
              </a:extLst>
            </p:cNvPr>
            <p:cNvCxnSpPr>
              <a:stCxn id="5" idx="2"/>
              <a:endCxn id="7" idx="0"/>
            </p:cNvCxnSpPr>
            <p:nvPr/>
          </p:nvCxnSpPr>
          <p:spPr>
            <a:xfrm>
              <a:off x="815389" y="1101988"/>
              <a:ext cx="0" cy="229789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直接箭头连接符 21">
              <a:extLst>
                <a:ext uri="{FF2B5EF4-FFF2-40B4-BE49-F238E27FC236}">
                  <a16:creationId xmlns:a16="http://schemas.microsoft.com/office/drawing/2014/main" id="{DAE932B4-7438-4C6A-A903-60D29D459A26}"/>
                </a:ext>
              </a:extLst>
            </p:cNvPr>
            <p:cNvCxnSpPr>
              <a:cxnSpLocks/>
              <a:stCxn id="6" idx="2"/>
              <a:endCxn id="8" idx="0"/>
            </p:cNvCxnSpPr>
            <p:nvPr/>
          </p:nvCxnSpPr>
          <p:spPr>
            <a:xfrm>
              <a:off x="2217916" y="1101988"/>
              <a:ext cx="0" cy="229789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直接箭头连接符 22">
              <a:extLst>
                <a:ext uri="{FF2B5EF4-FFF2-40B4-BE49-F238E27FC236}">
                  <a16:creationId xmlns:a16="http://schemas.microsoft.com/office/drawing/2014/main" id="{EB5FEA8E-FFEF-4F96-830A-D4E0C7D84ADE}"/>
                </a:ext>
              </a:extLst>
            </p:cNvPr>
            <p:cNvCxnSpPr>
              <a:cxnSpLocks/>
              <a:stCxn id="8" idx="2"/>
            </p:cNvCxnSpPr>
            <p:nvPr/>
          </p:nvCxnSpPr>
          <p:spPr>
            <a:xfrm>
              <a:off x="2217916" y="1627994"/>
              <a:ext cx="0" cy="229789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直接箭头连接符 23">
              <a:extLst>
                <a:ext uri="{FF2B5EF4-FFF2-40B4-BE49-F238E27FC236}">
                  <a16:creationId xmlns:a16="http://schemas.microsoft.com/office/drawing/2014/main" id="{3C820814-6123-44F2-BB30-DFAC27D8F445}"/>
                </a:ext>
              </a:extLst>
            </p:cNvPr>
            <p:cNvCxnSpPr>
              <a:cxnSpLocks/>
              <a:stCxn id="7" idx="2"/>
            </p:cNvCxnSpPr>
            <p:nvPr/>
          </p:nvCxnSpPr>
          <p:spPr>
            <a:xfrm>
              <a:off x="815389" y="1627994"/>
              <a:ext cx="0" cy="229789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5" name="直接箭头连接符 24">
              <a:extLst>
                <a:ext uri="{FF2B5EF4-FFF2-40B4-BE49-F238E27FC236}">
                  <a16:creationId xmlns:a16="http://schemas.microsoft.com/office/drawing/2014/main" id="{243932C3-F370-4ED6-966F-14879CD5BF45}"/>
                </a:ext>
              </a:extLst>
            </p:cNvPr>
            <p:cNvCxnSpPr>
              <a:cxnSpLocks/>
              <a:stCxn id="9" idx="2"/>
              <a:endCxn id="10" idx="0"/>
            </p:cNvCxnSpPr>
            <p:nvPr/>
          </p:nvCxnSpPr>
          <p:spPr>
            <a:xfrm>
              <a:off x="1610463" y="2154001"/>
              <a:ext cx="0" cy="229789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8" name="直接箭头连接符 27">
              <a:extLst>
                <a:ext uri="{FF2B5EF4-FFF2-40B4-BE49-F238E27FC236}">
                  <a16:creationId xmlns:a16="http://schemas.microsoft.com/office/drawing/2014/main" id="{F73F8FEA-F4BE-4298-A6E2-CD21A26CA5ED}"/>
                </a:ext>
              </a:extLst>
            </p:cNvPr>
            <p:cNvCxnSpPr>
              <a:cxnSpLocks/>
              <a:stCxn id="10" idx="2"/>
              <a:endCxn id="11" idx="0"/>
            </p:cNvCxnSpPr>
            <p:nvPr/>
          </p:nvCxnSpPr>
          <p:spPr>
            <a:xfrm>
              <a:off x="1610463" y="2680010"/>
              <a:ext cx="0" cy="229789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直接箭头连接符 34">
              <a:extLst>
                <a:ext uri="{FF2B5EF4-FFF2-40B4-BE49-F238E27FC236}">
                  <a16:creationId xmlns:a16="http://schemas.microsoft.com/office/drawing/2014/main" id="{8AA24876-5B97-4BF9-8DFE-BC6B938EB647}"/>
                </a:ext>
              </a:extLst>
            </p:cNvPr>
            <p:cNvCxnSpPr>
              <a:cxnSpLocks/>
              <a:stCxn id="17" idx="2"/>
              <a:endCxn id="18" idx="0"/>
            </p:cNvCxnSpPr>
            <p:nvPr/>
          </p:nvCxnSpPr>
          <p:spPr>
            <a:xfrm>
              <a:off x="4663258" y="2154001"/>
              <a:ext cx="0" cy="229789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直接箭头连接符 37">
              <a:extLst>
                <a:ext uri="{FF2B5EF4-FFF2-40B4-BE49-F238E27FC236}">
                  <a16:creationId xmlns:a16="http://schemas.microsoft.com/office/drawing/2014/main" id="{80AD43D9-630D-41EE-8586-65B11762B8C6}"/>
                </a:ext>
              </a:extLst>
            </p:cNvPr>
            <p:cNvCxnSpPr>
              <a:cxnSpLocks/>
              <a:stCxn id="18" idx="2"/>
              <a:endCxn id="19" idx="0"/>
            </p:cNvCxnSpPr>
            <p:nvPr/>
          </p:nvCxnSpPr>
          <p:spPr>
            <a:xfrm>
              <a:off x="4663258" y="2680010"/>
              <a:ext cx="0" cy="229789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1" name="直接箭头连接符 40">
              <a:extLst>
                <a:ext uri="{FF2B5EF4-FFF2-40B4-BE49-F238E27FC236}">
                  <a16:creationId xmlns:a16="http://schemas.microsoft.com/office/drawing/2014/main" id="{F0C610B5-750D-4C68-B02D-FD0E78DF3C8C}"/>
                </a:ext>
              </a:extLst>
            </p:cNvPr>
            <p:cNvCxnSpPr>
              <a:cxnSpLocks/>
              <a:stCxn id="16" idx="2"/>
              <a:endCxn id="17" idx="0"/>
            </p:cNvCxnSpPr>
            <p:nvPr/>
          </p:nvCxnSpPr>
          <p:spPr>
            <a:xfrm>
              <a:off x="4663258" y="1627994"/>
              <a:ext cx="0" cy="229789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5" name="直接箭头连接符 44">
              <a:extLst>
                <a:ext uri="{FF2B5EF4-FFF2-40B4-BE49-F238E27FC236}">
                  <a16:creationId xmlns:a16="http://schemas.microsoft.com/office/drawing/2014/main" id="{7E73C0C0-CA70-4C05-9992-F02755D1F1B5}"/>
                </a:ext>
              </a:extLst>
            </p:cNvPr>
            <p:cNvCxnSpPr>
              <a:cxnSpLocks/>
              <a:stCxn id="12" idx="2"/>
            </p:cNvCxnSpPr>
            <p:nvPr/>
          </p:nvCxnSpPr>
          <p:spPr>
            <a:xfrm>
              <a:off x="3793979" y="1101988"/>
              <a:ext cx="0" cy="229786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8" name="直接箭头连接符 47">
              <a:extLst>
                <a:ext uri="{FF2B5EF4-FFF2-40B4-BE49-F238E27FC236}">
                  <a16:creationId xmlns:a16="http://schemas.microsoft.com/office/drawing/2014/main" id="{DE8A9431-B6AC-4D69-9222-191F5755EB60}"/>
                </a:ext>
              </a:extLst>
            </p:cNvPr>
            <p:cNvCxnSpPr>
              <a:cxnSpLocks/>
              <a:endCxn id="16" idx="0"/>
            </p:cNvCxnSpPr>
            <p:nvPr/>
          </p:nvCxnSpPr>
          <p:spPr>
            <a:xfrm>
              <a:off x="4663261" y="1107900"/>
              <a:ext cx="0" cy="223875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9" name="直接箭头连接符 48">
              <a:extLst>
                <a:ext uri="{FF2B5EF4-FFF2-40B4-BE49-F238E27FC236}">
                  <a16:creationId xmlns:a16="http://schemas.microsoft.com/office/drawing/2014/main" id="{2A0C6A6F-8A06-410B-BF5F-F9B285A5264D}"/>
                </a:ext>
              </a:extLst>
            </p:cNvPr>
            <p:cNvCxnSpPr>
              <a:cxnSpLocks/>
            </p:cNvCxnSpPr>
            <p:nvPr/>
          </p:nvCxnSpPr>
          <p:spPr>
            <a:xfrm>
              <a:off x="5573373" y="1113814"/>
              <a:ext cx="0" cy="209597"/>
            </a:xfrm>
            <a:prstGeom prst="straightConnector1">
              <a:avLst/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2" name="连接符: 肘形 61">
              <a:extLst>
                <a:ext uri="{FF2B5EF4-FFF2-40B4-BE49-F238E27FC236}">
                  <a16:creationId xmlns:a16="http://schemas.microsoft.com/office/drawing/2014/main" id="{73695144-BF67-42A0-B002-AECE73F4CDE0}"/>
                </a:ext>
              </a:extLst>
            </p:cNvPr>
            <p:cNvCxnSpPr>
              <a:cxnSpLocks/>
              <a:stCxn id="10" idx="3"/>
              <a:endCxn id="16" idx="1"/>
            </p:cNvCxnSpPr>
            <p:nvPr/>
          </p:nvCxnSpPr>
          <p:spPr>
            <a:xfrm flipV="1">
              <a:off x="2890909" y="1479883"/>
              <a:ext cx="491911" cy="1052017"/>
            </a:xfrm>
            <a:prstGeom prst="bentConnector3">
              <a:avLst>
                <a:gd name="adj1" fmla="val 50000"/>
              </a:avLst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3" name="连接符: 肘形 62">
              <a:extLst>
                <a:ext uri="{FF2B5EF4-FFF2-40B4-BE49-F238E27FC236}">
                  <a16:creationId xmlns:a16="http://schemas.microsoft.com/office/drawing/2014/main" id="{AAF5D2D7-F017-45A3-956C-B3A95C379CB4}"/>
                </a:ext>
              </a:extLst>
            </p:cNvPr>
            <p:cNvCxnSpPr>
              <a:cxnSpLocks/>
              <a:stCxn id="11" idx="3"/>
              <a:endCxn id="17" idx="1"/>
            </p:cNvCxnSpPr>
            <p:nvPr/>
          </p:nvCxnSpPr>
          <p:spPr>
            <a:xfrm flipV="1">
              <a:off x="2890909" y="2005890"/>
              <a:ext cx="491911" cy="1052017"/>
            </a:xfrm>
            <a:prstGeom prst="bentConnector3">
              <a:avLst>
                <a:gd name="adj1" fmla="val 50000"/>
              </a:avLst>
            </a:prstGeom>
            <a:ln w="158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0" name="文本框 79">
              <a:extLst>
                <a:ext uri="{FF2B5EF4-FFF2-40B4-BE49-F238E27FC236}">
                  <a16:creationId xmlns:a16="http://schemas.microsoft.com/office/drawing/2014/main" id="{3E1F718F-1E4A-4386-BCED-BBE1716FF1F5}"/>
                </a:ext>
              </a:extLst>
            </p:cNvPr>
            <p:cNvSpPr txBox="1"/>
            <p:nvPr/>
          </p:nvSpPr>
          <p:spPr>
            <a:xfrm>
              <a:off x="770309" y="489108"/>
              <a:ext cx="1814920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3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SIsensor</a:t>
              </a:r>
              <a:r>
                <a:rPr lang="en-US" altLang="zh-CN" sz="1103" b="1" dirty="0">
                  <a:latin typeface="Arial" panose="020B0604020202020204" pitchFamily="34" charset="0"/>
                  <a:cs typeface="Arial" panose="020B0604020202020204" pitchFamily="34" charset="0"/>
                </a:rPr>
                <a:t>-RNA training</a:t>
              </a:r>
              <a:endParaRPr lang="zh-CN" altLang="en-US" sz="1103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1" name="文本框 80">
              <a:extLst>
                <a:ext uri="{FF2B5EF4-FFF2-40B4-BE49-F238E27FC236}">
                  <a16:creationId xmlns:a16="http://schemas.microsoft.com/office/drawing/2014/main" id="{B414E23E-760F-4021-A4ED-88EF5E360416}"/>
                </a:ext>
              </a:extLst>
            </p:cNvPr>
            <p:cNvSpPr txBox="1"/>
            <p:nvPr/>
          </p:nvSpPr>
          <p:spPr>
            <a:xfrm>
              <a:off x="3851769" y="489108"/>
              <a:ext cx="1758815" cy="26205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zh-CN" sz="1103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MSIsensor</a:t>
              </a:r>
              <a:r>
                <a:rPr lang="en-US" altLang="zh-CN" sz="1103" b="1" dirty="0">
                  <a:latin typeface="Arial" panose="020B0604020202020204" pitchFamily="34" charset="0"/>
                  <a:cs typeface="Arial" panose="020B0604020202020204" pitchFamily="34" charset="0"/>
                </a:rPr>
                <a:t>-RNA testing</a:t>
              </a:r>
              <a:endParaRPr lang="zh-CN" altLang="en-US" sz="1103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1735136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3</TotalTime>
  <Words>34</Words>
  <Application>Microsoft Office PowerPoint</Application>
  <PresentationFormat>自定义</PresentationFormat>
  <Paragraphs>16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等线</vt:lpstr>
      <vt:lpstr>等线 Light</vt:lpstr>
      <vt:lpstr>Arial</vt:lpstr>
      <vt:lpstr>Calibri</vt:lpstr>
      <vt:lpstr>Calibri Light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peng Jia</dc:creator>
  <cp:lastModifiedBy>PENG JIA</cp:lastModifiedBy>
  <cp:revision>9</cp:revision>
  <dcterms:created xsi:type="dcterms:W3CDTF">2021-12-09T03:34:22Z</dcterms:created>
  <dcterms:modified xsi:type="dcterms:W3CDTF">2023-10-17T14:54:55Z</dcterms:modified>
</cp:coreProperties>
</file>